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notesSlides/notesSlide2.xml" ContentType="application/vnd.openxmlformats-officedocument.presentationml.notesSlid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61" r:id="rId2"/>
    <p:sldId id="262" r:id="rId3"/>
    <p:sldId id="272" r:id="rId4"/>
    <p:sldId id="267" r:id="rId5"/>
    <p:sldId id="256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266" autoAdjust="0"/>
    <p:restoredTop sz="96076" autoAdjust="0"/>
  </p:normalViewPr>
  <p:slideViewPr>
    <p:cSldViewPr snapToGrid="0" showGuides="1">
      <p:cViewPr varScale="1">
        <p:scale>
          <a:sx n="105" d="100"/>
          <a:sy n="105" d="100"/>
        </p:scale>
        <p:origin x="1362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Data\&#36786;&#30740;&#27231;&#27083;&#65288;H28-30&#65289;\&#29702;&#20107;&#38263;&#35009;&#37327;&#32076;&#36027;&#24540;&#21215;\Phytohormon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Data\&#36786;&#30740;&#27231;&#27083;&#65288;H28-30&#65289;\&#29702;&#20107;&#38263;&#35009;&#37327;&#32076;&#36027;&#24540;&#21215;\Phytohormon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mikamurata\Desktop\&#36865;&#20449;&#20104;&#23450;\190902~&#945;&#12520;&#12494;&#12531;text\191101Data\181024&#945;-ionone&#33976;&#27671;micro%20Tom-&#12488;&#12510;&#12495;&#12514;&#65343;&#25244;&#31883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home\tk\work\bph\loliolide\&#945;&#12520;&#12494;&#12531;&#12487;&#12540;&#12479;2018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home\tk\work\bph\loliolide\&#945;&#12520;&#12494;&#12531;&#12487;&#12540;&#12479;2018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aph!$P$6:$Q$6</c:f>
                <c:numCache>
                  <c:formatCode>General</c:formatCode>
                  <c:ptCount val="2"/>
                  <c:pt idx="0">
                    <c:v>4.5943128094169507</c:v>
                  </c:pt>
                  <c:pt idx="1">
                    <c:v>84.193390020899145</c:v>
                  </c:pt>
                </c:numCache>
              </c:numRef>
            </c:plus>
            <c:minus>
              <c:numRef>
                <c:f>graph!$P$6:$Q$6</c:f>
                <c:numCache>
                  <c:formatCode>General</c:formatCode>
                  <c:ptCount val="2"/>
                  <c:pt idx="0">
                    <c:v>4.5943128094169507</c:v>
                  </c:pt>
                  <c:pt idx="1">
                    <c:v>84.1933900208991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graph!$P$5:$Q$5</c:f>
              <c:numCache>
                <c:formatCode>General</c:formatCode>
                <c:ptCount val="2"/>
                <c:pt idx="0">
                  <c:v>194.0317990843771</c:v>
                </c:pt>
                <c:pt idx="1">
                  <c:v>227.292058504310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74-43A3-B873-D1EBB6EC79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0887464"/>
        <c:axId val="500884512"/>
      </c:barChart>
      <c:catAx>
        <c:axId val="500887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0884512"/>
        <c:crosses val="autoZero"/>
        <c:auto val="1"/>
        <c:lblAlgn val="ctr"/>
        <c:lblOffset val="100"/>
        <c:noMultiLvlLbl val="0"/>
      </c:catAx>
      <c:valAx>
        <c:axId val="500884512"/>
        <c:scaling>
          <c:orientation val="minMax"/>
          <c:max val="4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00887464"/>
        <c:crosses val="autoZero"/>
        <c:crossBetween val="between"/>
        <c:majorUnit val="1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12700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Phytohormone.xlsx]graph!$S$6:$T$6</c:f>
                <c:numCache>
                  <c:formatCode>General</c:formatCode>
                  <c:ptCount val="2"/>
                  <c:pt idx="0">
                    <c:v>47.575579098581649</c:v>
                  </c:pt>
                  <c:pt idx="1">
                    <c:v>45.508225658035528</c:v>
                  </c:pt>
                </c:numCache>
              </c:numRef>
            </c:plus>
            <c:minus>
              <c:numRef>
                <c:f>[Phytohormone.xlsx]graph!$S$6:$T$6</c:f>
                <c:numCache>
                  <c:formatCode>General</c:formatCode>
                  <c:ptCount val="2"/>
                  <c:pt idx="0">
                    <c:v>47.575579098581649</c:v>
                  </c:pt>
                  <c:pt idx="1">
                    <c:v>45.5082256580355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[Phytohormone.xlsx]graph!$S$5:$T$5</c:f>
              <c:numCache>
                <c:formatCode>General</c:formatCode>
                <c:ptCount val="2"/>
                <c:pt idx="0">
                  <c:v>186.64158010214217</c:v>
                </c:pt>
                <c:pt idx="1">
                  <c:v>234.775031598987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FF-424E-9ED2-AD97752A87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0887464"/>
        <c:axId val="500884512"/>
      </c:barChart>
      <c:catAx>
        <c:axId val="500887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0884512"/>
        <c:crosses val="autoZero"/>
        <c:auto val="1"/>
        <c:lblAlgn val="ctr"/>
        <c:lblOffset val="100"/>
        <c:noMultiLvlLbl val="0"/>
      </c:catAx>
      <c:valAx>
        <c:axId val="500884512"/>
        <c:scaling>
          <c:orientation val="minMax"/>
          <c:max val="4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00887464"/>
        <c:crosses val="autoZero"/>
        <c:crossBetween val="between"/>
        <c:majorUnit val="1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12700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157240801173603"/>
          <c:y val="3.7115981456374895E-2"/>
          <c:w val="0.63659946373347009"/>
          <c:h val="0.843099862030161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181026Fig. '!$D$28:$D$32</c:f>
                <c:numCache>
                  <c:formatCode>General</c:formatCode>
                  <c:ptCount val="5"/>
                  <c:pt idx="0">
                    <c:v>7.58</c:v>
                  </c:pt>
                  <c:pt idx="1">
                    <c:v>9.25</c:v>
                  </c:pt>
                  <c:pt idx="2">
                    <c:v>8.26</c:v>
                  </c:pt>
                  <c:pt idx="3">
                    <c:v>7.51</c:v>
                  </c:pt>
                  <c:pt idx="4">
                    <c:v>3.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181026Fig. '!$B$28:$B$32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10</c:v>
                </c:pt>
                <c:pt idx="3">
                  <c:v>100</c:v>
                </c:pt>
                <c:pt idx="4">
                  <c:v>300</c:v>
                </c:pt>
              </c:numCache>
            </c:numRef>
          </c:cat>
          <c:val>
            <c:numRef>
              <c:f>'181026Fig. '!$C$28:$C$32</c:f>
              <c:numCache>
                <c:formatCode>General</c:formatCode>
                <c:ptCount val="5"/>
                <c:pt idx="0">
                  <c:v>13.38</c:v>
                </c:pt>
                <c:pt idx="1">
                  <c:v>10.29</c:v>
                </c:pt>
                <c:pt idx="2">
                  <c:v>11.4</c:v>
                </c:pt>
                <c:pt idx="3">
                  <c:v>11.89</c:v>
                </c:pt>
                <c:pt idx="4">
                  <c:v>6.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0F-BC4F-AF18-4956263E12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6695600"/>
        <c:axId val="1925822288"/>
      </c:barChart>
      <c:catAx>
        <c:axId val="1956695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925822288"/>
        <c:crosses val="autoZero"/>
        <c:auto val="1"/>
        <c:lblAlgn val="ctr"/>
        <c:lblOffset val="100"/>
        <c:noMultiLvlLbl val="0"/>
      </c:catAx>
      <c:valAx>
        <c:axId val="1925822288"/>
        <c:scaling>
          <c:orientation val="minMax"/>
          <c:max val="25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956695600"/>
        <c:crosses val="autoZero"/>
        <c:crossBetween val="between"/>
        <c:majorUnit val="5"/>
      </c:valAx>
      <c:spPr>
        <a:ln w="1270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83777777777781"/>
          <c:y val="5.9007207759000917E-2"/>
          <c:w val="0.80108730057591981"/>
          <c:h val="0.8379287253886313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ays_graph!$B$12:$F$12</c:f>
                <c:numCache>
                  <c:formatCode>General</c:formatCode>
                  <c:ptCount val="4"/>
                  <c:pt idx="0">
                    <c:v>0.95828004966960034</c:v>
                  </c:pt>
                  <c:pt idx="1">
                    <c:v>0.37463432463267737</c:v>
                  </c:pt>
                  <c:pt idx="2">
                    <c:v>1.3243285671789129</c:v>
                  </c:pt>
                  <c:pt idx="3">
                    <c:v>0.5</c:v>
                  </c:pt>
                </c:numCache>
                <c:extLst/>
              </c:numRef>
            </c:plus>
            <c:minus>
              <c:numRef>
                <c:f>days_graph!$B$12:$F$12</c:f>
                <c:numCache>
                  <c:formatCode>General</c:formatCode>
                  <c:ptCount val="4"/>
                  <c:pt idx="0">
                    <c:v>0.95828004966960034</c:v>
                  </c:pt>
                  <c:pt idx="1">
                    <c:v>0.37463432463267737</c:v>
                  </c:pt>
                  <c:pt idx="2">
                    <c:v>1.3243285671789129</c:v>
                  </c:pt>
                  <c:pt idx="3">
                    <c:v>0.5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ays_graph!$B$10:$F$10</c:f>
              <c:strCache>
                <c:ptCount val="4"/>
                <c:pt idx="0">
                  <c:v>0</c:v>
                </c:pt>
                <c:pt idx="1">
                  <c:v>100</c:v>
                </c:pt>
                <c:pt idx="2">
                  <c:v>300</c:v>
                </c:pt>
                <c:pt idx="3">
                  <c:v>900</c:v>
                </c:pt>
              </c:strCache>
              <c:extLst/>
            </c:strRef>
          </c:cat>
          <c:val>
            <c:numRef>
              <c:f>days_graph!$B$11:$F$11</c:f>
              <c:numCache>
                <c:formatCode>General</c:formatCode>
                <c:ptCount val="4"/>
                <c:pt idx="0">
                  <c:v>9.7222222222222214</c:v>
                </c:pt>
                <c:pt idx="1">
                  <c:v>8.8421052631578956</c:v>
                </c:pt>
                <c:pt idx="2">
                  <c:v>9.0769230769230766</c:v>
                </c:pt>
                <c:pt idx="3">
                  <c:v>8.7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FE2F-47E9-9906-CD0B45D808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2002167712"/>
        <c:axId val="1893126272"/>
      </c:barChart>
      <c:catAx>
        <c:axId val="2002167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93126272"/>
        <c:crosses val="autoZero"/>
        <c:auto val="1"/>
        <c:lblAlgn val="ctr"/>
        <c:lblOffset val="100"/>
        <c:noMultiLvlLbl val="0"/>
      </c:catAx>
      <c:valAx>
        <c:axId val="1893126272"/>
        <c:scaling>
          <c:orientation val="minMax"/>
          <c:max val="13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0216771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36782887761578"/>
          <c:y val="6.0253673397698153E-2"/>
          <c:w val="0.81982463424359642"/>
          <c:h val="0.847935207126287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dult_rate!$B$32:$F$32</c:f>
                <c:numCache>
                  <c:formatCode>General</c:formatCode>
                  <c:ptCount val="4"/>
                  <c:pt idx="0">
                    <c:v>0.16905320804532439</c:v>
                  </c:pt>
                  <c:pt idx="1">
                    <c:v>0.15485443218885042</c:v>
                  </c:pt>
                  <c:pt idx="2">
                    <c:v>7.483997341989411E-2</c:v>
                  </c:pt>
                  <c:pt idx="3">
                    <c:v>0.46711645450723344</c:v>
                  </c:pt>
                </c:numCache>
                <c:extLst/>
              </c:numRef>
            </c:plus>
            <c:minus>
              <c:numRef>
                <c:f>adult_rate!$B$32:$F$32</c:f>
                <c:numCache>
                  <c:formatCode>General</c:formatCode>
                  <c:ptCount val="4"/>
                  <c:pt idx="0">
                    <c:v>0.16905320804532439</c:v>
                  </c:pt>
                  <c:pt idx="1">
                    <c:v>0.15485443218885042</c:v>
                  </c:pt>
                  <c:pt idx="2">
                    <c:v>7.483997341989411E-2</c:v>
                  </c:pt>
                  <c:pt idx="3">
                    <c:v>0.46711645450723344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adult_rate!$B$27:$F$27</c:f>
              <c:strCache>
                <c:ptCount val="4"/>
                <c:pt idx="0">
                  <c:v>0</c:v>
                </c:pt>
                <c:pt idx="1">
                  <c:v>100</c:v>
                </c:pt>
                <c:pt idx="2">
                  <c:v>300</c:v>
                </c:pt>
                <c:pt idx="3">
                  <c:v>900</c:v>
                </c:pt>
              </c:strCache>
              <c:extLst/>
            </c:strRef>
          </c:cat>
          <c:val>
            <c:numRef>
              <c:f>adult_rate!$B$31:$F$31</c:f>
              <c:numCache>
                <c:formatCode>General</c:formatCode>
                <c:ptCount val="4"/>
                <c:pt idx="0">
                  <c:v>0.5984126984126984</c:v>
                </c:pt>
                <c:pt idx="1">
                  <c:v>0.80418719211822653</c:v>
                </c:pt>
                <c:pt idx="2">
                  <c:v>0.90517241379310354</c:v>
                </c:pt>
                <c:pt idx="3">
                  <c:v>0.6932234432234433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1D07-47EE-BB5D-F719E52E0A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951604928"/>
        <c:axId val="1893105536"/>
      </c:barChart>
      <c:catAx>
        <c:axId val="19516049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93105536"/>
        <c:crosses val="autoZero"/>
        <c:auto val="0"/>
        <c:lblAlgn val="ctr"/>
        <c:lblOffset val="100"/>
        <c:noMultiLvlLbl val="0"/>
      </c:catAx>
      <c:valAx>
        <c:axId val="1893105536"/>
        <c:scaling>
          <c:orientation val="minMax"/>
          <c:max val="1.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951604928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BE2800-92B4-7349-B306-55E3F9EEE6B5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0AF3C6-D2EA-FA44-9782-34929F1EDA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896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l-GR" altLang="ja-JP" dirty="0"/>
              <a:t>181024α-</a:t>
            </a:r>
            <a:r>
              <a:rPr kumimoji="1" lang="en-US" altLang="ja-JP" dirty="0"/>
              <a:t>ionone</a:t>
            </a:r>
            <a:r>
              <a:rPr kumimoji="1" lang="ja-JP" altLang="en-US"/>
              <a:t>蒸気</a:t>
            </a:r>
            <a:r>
              <a:rPr kumimoji="1" lang="en-US" altLang="ja-JP" dirty="0"/>
              <a:t>micro Tom-</a:t>
            </a:r>
            <a:r>
              <a:rPr kumimoji="1" lang="ja-JP" altLang="en-US"/>
              <a:t>トマハモ＿抜粋</a:t>
            </a:r>
            <a:r>
              <a:rPr kumimoji="1" lang="en-US" altLang="ja-JP" dirty="0"/>
              <a:t>.xlsx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20AF3C6-D2EA-FA44-9782-34929F1EDAF7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3853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20AF3C6-D2EA-FA44-9782-34929F1EDAF7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119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5538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6815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0349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369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520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4915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941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114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568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93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889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0FCC9-DD0F-455C-8A35-703458E98F5C}" type="datetimeFigureOut">
              <a:rPr kumimoji="1" lang="ja-JP" altLang="en-US" smtClean="0"/>
              <a:t>2019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CFE5A-9561-47A8-AFA2-7342D6937C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140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9F76123-98DF-4F78-963B-79416AF904D6}"/>
              </a:ext>
            </a:extLst>
          </p:cNvPr>
          <p:cNvSpPr txBox="1"/>
          <p:nvPr/>
        </p:nvSpPr>
        <p:spPr>
          <a:xfrm>
            <a:off x="1711908" y="4722076"/>
            <a:ext cx="474995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 set-up for the treatment 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omato plants with </a:t>
            </a:r>
            <a:r>
              <a:rPr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one vapor.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1">
            <a:extLst>
              <a:ext uri="{FF2B5EF4-FFF2-40B4-BE49-F238E27FC236}">
                <a16:creationId xmlns:a16="http://schemas.microsoft.com/office/drawing/2014/main" id="{08A954BE-3ACC-4AE4-A47B-19B3C475A9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142"/>
          <a:stretch/>
        </p:blipFill>
        <p:spPr>
          <a:xfrm>
            <a:off x="2897394" y="1371599"/>
            <a:ext cx="2659702" cy="3022189"/>
          </a:xfrm>
          <a:prstGeom prst="rect">
            <a:avLst/>
          </a:prstGeom>
        </p:spPr>
      </p:pic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90C0BB38-F349-4D86-AEF2-D6167A389168}"/>
              </a:ext>
            </a:extLst>
          </p:cNvPr>
          <p:cNvCxnSpPr>
            <a:cxnSpLocks/>
          </p:cNvCxnSpPr>
          <p:nvPr/>
        </p:nvCxnSpPr>
        <p:spPr>
          <a:xfrm>
            <a:off x="5441796" y="2062975"/>
            <a:ext cx="0" cy="185110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54CF7D5-5436-468E-A094-DD476276A40D}"/>
              </a:ext>
            </a:extLst>
          </p:cNvPr>
          <p:cNvSpPr txBox="1"/>
          <p:nvPr/>
        </p:nvSpPr>
        <p:spPr>
          <a:xfrm>
            <a:off x="4996627" y="3132583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 </a:t>
            </a:r>
          </a:p>
          <a:p>
            <a:r>
              <a:rPr kumimoji="1" lang="en-US" altLang="ja-JP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  <a:endParaRPr kumimoji="1" lang="ja-JP" altLang="en-US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80BE37A-2494-41DF-9F4C-5546A945142C}"/>
              </a:ext>
            </a:extLst>
          </p:cNvPr>
          <p:cNvSpPr txBox="1"/>
          <p:nvPr/>
        </p:nvSpPr>
        <p:spPr>
          <a:xfrm>
            <a:off x="3096807" y="965796"/>
            <a:ext cx="1130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ylon mesh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ADF22659-69AB-4D1D-AB0D-2F83E5DCEBF0}"/>
              </a:ext>
            </a:extLst>
          </p:cNvPr>
          <p:cNvCxnSpPr/>
          <p:nvPr/>
        </p:nvCxnSpPr>
        <p:spPr>
          <a:xfrm>
            <a:off x="3836020" y="1273573"/>
            <a:ext cx="245326" cy="41259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8960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9F76123-98DF-4F78-963B-79416AF904D6}"/>
              </a:ext>
            </a:extLst>
          </p:cNvPr>
          <p:cNvSpPr txBox="1"/>
          <p:nvPr/>
        </p:nvSpPr>
        <p:spPr>
          <a:xfrm>
            <a:off x="1065074" y="4894517"/>
            <a:ext cx="698750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</a:t>
            </a:r>
            <a:r>
              <a:rPr kumimoji="1"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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one on the accumulation of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smonic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and salicylic acid in tomato leaves. Concentrations of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smonic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and salicylic acid in tomato leaves exposed to 300 </a:t>
            </a:r>
            <a:r>
              <a:rPr kumimoji="1"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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kumimoji="1"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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one or solvent alone (Control) for 24 h. Values are the mean ± SD (n = 3 replicates, 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gt; 0.05, 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)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158B82FA-4E52-4B28-897C-252504D881F9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399714" y="1719960"/>
          <a:ext cx="3157190" cy="2771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25A4BC4F-310C-4AFC-9DBF-F8C7D4494AF1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895385" y="1719960"/>
          <a:ext cx="3157190" cy="2771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A9BAB5E-C97F-48FB-895E-CD3BC8751F11}"/>
              </a:ext>
            </a:extLst>
          </p:cNvPr>
          <p:cNvSpPr txBox="1"/>
          <p:nvPr/>
        </p:nvSpPr>
        <p:spPr>
          <a:xfrm rot="16200000">
            <a:off x="3708094" y="2907128"/>
            <a:ext cx="2111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alicylic acid (ng gFW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86F1B30-DE5B-4C91-AD30-65879F09023C}"/>
              </a:ext>
            </a:extLst>
          </p:cNvPr>
          <p:cNvSpPr txBox="1"/>
          <p:nvPr/>
        </p:nvSpPr>
        <p:spPr>
          <a:xfrm rot="16200000">
            <a:off x="109557" y="2907127"/>
            <a:ext cx="22188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asmonic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cid (ng gFW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68DD914-27AF-48D3-8798-9A78BD91C120}"/>
              </a:ext>
            </a:extLst>
          </p:cNvPr>
          <p:cNvSpPr txBox="1"/>
          <p:nvPr/>
        </p:nvSpPr>
        <p:spPr>
          <a:xfrm>
            <a:off x="2978309" y="1874504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C0B888D-DC6F-4C5F-817B-8DDAF30F6142}"/>
              </a:ext>
            </a:extLst>
          </p:cNvPr>
          <p:cNvSpPr txBox="1"/>
          <p:nvPr/>
        </p:nvSpPr>
        <p:spPr>
          <a:xfrm>
            <a:off x="6473980" y="1869585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BD62980-B045-4B90-8C50-F0E34EF70C0C}"/>
              </a:ext>
            </a:extLst>
          </p:cNvPr>
          <p:cNvSpPr txBox="1"/>
          <p:nvPr/>
        </p:nvSpPr>
        <p:spPr>
          <a:xfrm>
            <a:off x="2117165" y="4263278"/>
            <a:ext cx="211788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ntrol             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Iono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A50EE0D-D393-4CEF-9D78-8718DC13A8C0}"/>
              </a:ext>
            </a:extLst>
          </p:cNvPr>
          <p:cNvSpPr txBox="1"/>
          <p:nvPr/>
        </p:nvSpPr>
        <p:spPr>
          <a:xfrm>
            <a:off x="5555720" y="4263278"/>
            <a:ext cx="211788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Control             </a:t>
            </a:r>
            <a:r>
              <a:rPr kumimoji="1" lang="en-US" altLang="ja-JP" sz="140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-Ionon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13140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00000000-0008-0000-0200-00000400000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683822" y="1470736"/>
          <a:ext cx="3370339" cy="3341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7B0A629-2918-FA49-A8F4-744C357E615F}"/>
              </a:ext>
            </a:extLst>
          </p:cNvPr>
          <p:cNvSpPr txBox="1"/>
          <p:nvPr/>
        </p:nvSpPr>
        <p:spPr>
          <a:xfrm>
            <a:off x="3693275" y="1273573"/>
            <a:ext cx="1816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egetable 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leafmine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3147A46-FD3D-C041-87B3-AE6A5652AC19}"/>
              </a:ext>
            </a:extLst>
          </p:cNvPr>
          <p:cNvSpPr txBox="1"/>
          <p:nvPr/>
        </p:nvSpPr>
        <p:spPr>
          <a:xfrm rot="16200000">
            <a:off x="1593035" y="2833127"/>
            <a:ext cx="260199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umber of pupated individual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808F66C-6580-A040-BD58-C4A39E9AA68F}"/>
              </a:ext>
            </a:extLst>
          </p:cNvPr>
          <p:cNvSpPr txBox="1"/>
          <p:nvPr/>
        </p:nvSpPr>
        <p:spPr>
          <a:xfrm>
            <a:off x="4401932" y="1675501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9">
            <a:extLst>
              <a:ext uri="{FF2B5EF4-FFF2-40B4-BE49-F238E27FC236}">
                <a16:creationId xmlns:a16="http://schemas.microsoft.com/office/drawing/2014/main" id="{1A077D8B-9FB9-4F04-BB8D-1F0379264817}"/>
              </a:ext>
            </a:extLst>
          </p:cNvPr>
          <p:cNvSpPr txBox="1"/>
          <p:nvPr/>
        </p:nvSpPr>
        <p:spPr>
          <a:xfrm>
            <a:off x="3997789" y="4658157"/>
            <a:ext cx="1326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-Ionon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D708195-998B-4EAD-AE51-D6CE4D2D04D4}"/>
              </a:ext>
            </a:extLst>
          </p:cNvPr>
          <p:cNvSpPr txBox="1"/>
          <p:nvPr/>
        </p:nvSpPr>
        <p:spPr>
          <a:xfrm>
            <a:off x="908181" y="5171982"/>
            <a:ext cx="698750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</a:t>
            </a:r>
            <a:r>
              <a:rPr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one on the infestation of tomato leaves by the vegetable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fminer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omato plants were exposed to different concentrations of </a:t>
            </a:r>
            <a:r>
              <a:rPr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one for 24 h, and pairs of adult males and females were placed on the leaf surface. The numbers of pupated individuals were counted 14 d after the inoculation. Values are the mean ± SD (n = 7~10 replicates,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 0.05, one-way ANOVA)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08980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グラフ 29">
            <a:extLst>
              <a:ext uri="{FF2B5EF4-FFF2-40B4-BE49-F238E27FC236}">
                <a16:creationId xmlns:a16="http://schemas.microsoft.com/office/drawing/2014/main" id="{FFF9006B-C8EC-4DB2-806F-FEC174FF53B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986618" y="2083659"/>
          <a:ext cx="2432630" cy="24797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EB02972-35C7-457D-B128-6304AD69CE52}"/>
              </a:ext>
            </a:extLst>
          </p:cNvPr>
          <p:cNvSpPr txBox="1"/>
          <p:nvPr/>
        </p:nvSpPr>
        <p:spPr>
          <a:xfrm>
            <a:off x="2392826" y="4563367"/>
            <a:ext cx="136127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ionone (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30C68A7-8602-4781-A371-563D9FAC0541}"/>
              </a:ext>
            </a:extLst>
          </p:cNvPr>
          <p:cNvSpPr txBox="1"/>
          <p:nvPr/>
        </p:nvSpPr>
        <p:spPr>
          <a:xfrm rot="16200000">
            <a:off x="646881" y="3227343"/>
            <a:ext cx="166879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dult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closio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334AD2E-D6B4-491B-A45B-D4F6F1D89C95}"/>
              </a:ext>
            </a:extLst>
          </p:cNvPr>
          <p:cNvSpPr txBox="1"/>
          <p:nvPr/>
        </p:nvSpPr>
        <p:spPr>
          <a:xfrm>
            <a:off x="1299046" y="1808173"/>
            <a:ext cx="373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B753C98-7153-40E9-B779-18B83324E0A2}"/>
              </a:ext>
            </a:extLst>
          </p:cNvPr>
          <p:cNvSpPr txBox="1"/>
          <p:nvPr/>
        </p:nvSpPr>
        <p:spPr>
          <a:xfrm>
            <a:off x="5733167" y="4563367"/>
            <a:ext cx="136127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ionone (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0AE3ABE7-C08D-43CB-AF8D-58033450D93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656111" y="2083659"/>
          <a:ext cx="2432630" cy="24797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BA0638C-2C6D-4574-B454-2243E13737FC}"/>
              </a:ext>
            </a:extLst>
          </p:cNvPr>
          <p:cNvSpPr txBox="1"/>
          <p:nvPr/>
        </p:nvSpPr>
        <p:spPr>
          <a:xfrm rot="16200000">
            <a:off x="3628046" y="3006858"/>
            <a:ext cx="217169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verage days required  for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mpletion of adult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eclos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257CBAC-EB72-47DF-A4A4-9CEE8AE31BA3}"/>
              </a:ext>
            </a:extLst>
          </p:cNvPr>
          <p:cNvSpPr txBox="1"/>
          <p:nvPr/>
        </p:nvSpPr>
        <p:spPr>
          <a:xfrm>
            <a:off x="4483060" y="18033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CCA9E0C-99A2-4FE1-BEA5-42493BAFC3D8}"/>
              </a:ext>
            </a:extLst>
          </p:cNvPr>
          <p:cNvSpPr txBox="1"/>
          <p:nvPr/>
        </p:nvSpPr>
        <p:spPr>
          <a:xfrm>
            <a:off x="2130641" y="1929888"/>
            <a:ext cx="16866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rown planthoppe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1CB7E48-C442-4748-BEAB-DA9844B36E4E}"/>
              </a:ext>
            </a:extLst>
          </p:cNvPr>
          <p:cNvSpPr txBox="1"/>
          <p:nvPr/>
        </p:nvSpPr>
        <p:spPr>
          <a:xfrm>
            <a:off x="5500177" y="1929770"/>
            <a:ext cx="16866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rown planthoppe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92F137-0927-447E-9F78-7E1FF78C76D0}"/>
              </a:ext>
            </a:extLst>
          </p:cNvPr>
          <p:cNvSpPr txBox="1"/>
          <p:nvPr/>
        </p:nvSpPr>
        <p:spPr>
          <a:xfrm>
            <a:off x="1584211" y="245299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90D69C5-5FA0-450D-A469-9F44AB1AC3A5}"/>
              </a:ext>
            </a:extLst>
          </p:cNvPr>
          <p:cNvSpPr txBox="1"/>
          <p:nvPr/>
        </p:nvSpPr>
        <p:spPr>
          <a:xfrm>
            <a:off x="1668811" y="27730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3EA8361-F55E-4F1E-92F1-2E4A5D691AC7}"/>
              </a:ext>
            </a:extLst>
          </p:cNvPr>
          <p:cNvSpPr txBox="1"/>
          <p:nvPr/>
        </p:nvSpPr>
        <p:spPr>
          <a:xfrm>
            <a:off x="1668811" y="31145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E065068-61AB-4ECE-9348-128B215E2091}"/>
              </a:ext>
            </a:extLst>
          </p:cNvPr>
          <p:cNvSpPr txBox="1"/>
          <p:nvPr/>
        </p:nvSpPr>
        <p:spPr>
          <a:xfrm>
            <a:off x="1668811" y="34624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1EF473F-1082-4F7B-8308-9FDAA1EAFD59}"/>
              </a:ext>
            </a:extLst>
          </p:cNvPr>
          <p:cNvSpPr txBox="1"/>
          <p:nvPr/>
        </p:nvSpPr>
        <p:spPr>
          <a:xfrm>
            <a:off x="1668811" y="380392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D3AB51B-BD11-4284-97CE-14686D3D1972}"/>
              </a:ext>
            </a:extLst>
          </p:cNvPr>
          <p:cNvSpPr txBox="1"/>
          <p:nvPr/>
        </p:nvSpPr>
        <p:spPr>
          <a:xfrm>
            <a:off x="1753070" y="414222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C1F3D4D-8AD7-40D2-97C6-813076D3F462}"/>
              </a:ext>
            </a:extLst>
          </p:cNvPr>
          <p:cNvSpPr txBox="1"/>
          <p:nvPr/>
        </p:nvSpPr>
        <p:spPr>
          <a:xfrm>
            <a:off x="886916" y="5020077"/>
            <a:ext cx="698750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</a:t>
            </a:r>
            <a:r>
              <a:rPr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one on the infestation of rice leaves by the brown planthopper. Rice plants were exposed to different concentrations of </a:t>
            </a:r>
            <a:r>
              <a:rPr lang="en-US" altLang="ja-JP" sz="1400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one for 72 h, and 30 second-instar nymphs per 15 rice plants were released near the plants in a sealed pot. The survival and developmental stage of individuals were recorded every day until all individuals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losed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died. Values are the mean ± SD. (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rate of adult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losion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verage days to the completion of adult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losion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releasing nymphs. Data shown are a representative of three individual experiment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24210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EF1541ED-CD62-4951-B279-B337B3BBBE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8628973"/>
              </p:ext>
            </p:extLst>
          </p:nvPr>
        </p:nvGraphicFramePr>
        <p:xfrm>
          <a:off x="1875153" y="2553494"/>
          <a:ext cx="6166187" cy="243840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136832">
                  <a:extLst>
                    <a:ext uri="{9D8B030D-6E8A-4147-A177-3AD203B41FA5}">
                      <a16:colId xmlns:a16="http://schemas.microsoft.com/office/drawing/2014/main" val="3405225181"/>
                    </a:ext>
                  </a:extLst>
                </a:gridCol>
                <a:gridCol w="1329207">
                  <a:extLst>
                    <a:ext uri="{9D8B030D-6E8A-4147-A177-3AD203B41FA5}">
                      <a16:colId xmlns:a16="http://schemas.microsoft.com/office/drawing/2014/main" val="884938850"/>
                    </a:ext>
                  </a:extLst>
                </a:gridCol>
                <a:gridCol w="1227575">
                  <a:extLst>
                    <a:ext uri="{9D8B030D-6E8A-4147-A177-3AD203B41FA5}">
                      <a16:colId xmlns:a16="http://schemas.microsoft.com/office/drawing/2014/main" val="2094968536"/>
                    </a:ext>
                  </a:extLst>
                </a:gridCol>
                <a:gridCol w="2472573">
                  <a:extLst>
                    <a:ext uri="{9D8B030D-6E8A-4147-A177-3AD203B41FA5}">
                      <a16:colId xmlns:a16="http://schemas.microsoft.com/office/drawing/2014/main" val="330944412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abbreviation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description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 number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equence (5'–3') forward/reverse</a:t>
                      </a:r>
                      <a:endParaRPr lang="ja-JP" sz="105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558969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Pin2</a:t>
                      </a:r>
                      <a:endParaRPr lang="ja-JP" sz="1050" i="1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ase inhibitor II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03291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CTTCTGGATTGCCCA</a:t>
                      </a:r>
                      <a:b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ACAACTTGATGCCCAC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620420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LapA1</a:t>
                      </a:r>
                      <a:endParaRPr lang="ja-JP" sz="1050" i="1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ucine aminopeptidase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46933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ACTAATGATGTTTGGAA</a:t>
                      </a:r>
                      <a:b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GCAATTTTATTTAGGCA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390810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hi3</a:t>
                      </a:r>
                      <a:endParaRPr lang="ja-JP" sz="1050" i="1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ic endochitinase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47475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GCCTTTTTCGGTCAAAC</a:t>
                      </a:r>
                      <a:b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CATAGTATCTGTCTGACTGCTC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394608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hi9</a:t>
                      </a:r>
                      <a:endParaRPr lang="ja-JP" sz="1050" i="1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ic endochitinase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47474  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CAAACTTCCCATGAAAC</a:t>
                      </a:r>
                      <a:b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GGCCATTGACTACTTGGTG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46882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GluB</a:t>
                      </a:r>
                      <a:endParaRPr lang="ja-JP" sz="1050" i="1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ic β-1,3-glucanase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80608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TTTGTTTGTCATTCTGG</a:t>
                      </a:r>
                      <a:b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TTACCAGATCAGAGTGT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259562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Lin5</a:t>
                      </a:r>
                      <a:endParaRPr lang="ja-JP" sz="1050" i="1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-wall invertase 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47864  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GAAGGGATTGAGAATCGA</a:t>
                      </a:r>
                      <a:b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ATTCATTTGACCAACCC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441386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actin</a:t>
                      </a:r>
                      <a:endParaRPr lang="ja-JP" sz="1050" i="1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T012695</a:t>
                      </a:r>
                      <a:endParaRPr lang="ja-JP" sz="1050" kern="1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GGTATTGCTGATAGAATGAG</a:t>
                      </a:r>
                      <a:br>
                        <a:rPr lang="en-US" sz="11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CCTCCAATCCAGACAC</a:t>
                      </a:r>
                      <a:endParaRPr lang="ja-JP" sz="1050" kern="1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10992727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C456FC1C-AC40-4534-AB29-1886370ADC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63283" y="2196602"/>
            <a:ext cx="431945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Table 1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List of primers used in the present study.</a:t>
            </a:r>
            <a:endParaRPr kumimoji="0" lang="en-US" altLang="ja-JP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925471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4</TotalTime>
  <Words>427</Words>
  <Application>Microsoft Office PowerPoint</Application>
  <PresentationFormat>画面に合わせる (4:3)</PresentationFormat>
  <Paragraphs>69</Paragraphs>
  <Slides>5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AS</dc:creator>
  <cp:lastModifiedBy>NIAS</cp:lastModifiedBy>
  <cp:revision>76</cp:revision>
  <dcterms:created xsi:type="dcterms:W3CDTF">2019-08-31T02:33:42Z</dcterms:created>
  <dcterms:modified xsi:type="dcterms:W3CDTF">2019-12-18T23:13:48Z</dcterms:modified>
</cp:coreProperties>
</file>